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77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931236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730940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4179284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2433840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826999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208334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297995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3800598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708309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959663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916213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76589-106D-4443-A0F8-977DC7261C92}" type="datetimeFigureOut">
              <a:rPr lang="es-ES" smtClean="0"/>
              <a:pPr/>
              <a:t>15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F44E34-EC55-4D16-BFB8-516D4B8F7F8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2944948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6 Grupo"/>
          <p:cNvGrpSpPr/>
          <p:nvPr/>
        </p:nvGrpSpPr>
        <p:grpSpPr>
          <a:xfrm>
            <a:off x="842442" y="1137980"/>
            <a:ext cx="7667979" cy="3803958"/>
            <a:chOff x="842442" y="1137980"/>
            <a:chExt cx="7667979" cy="3803958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1640" y="1213620"/>
              <a:ext cx="7178781" cy="37283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5 CuadroTexto"/>
            <p:cNvSpPr txBox="1"/>
            <p:nvPr/>
          </p:nvSpPr>
          <p:spPr>
            <a:xfrm>
              <a:off x="919834" y="1137980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1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910309" y="1404680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2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9 CuadroTexto"/>
            <p:cNvSpPr txBox="1"/>
            <p:nvPr/>
          </p:nvSpPr>
          <p:spPr>
            <a:xfrm>
              <a:off x="909117" y="1670611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3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10 CuadroTexto"/>
            <p:cNvSpPr txBox="1"/>
            <p:nvPr/>
          </p:nvSpPr>
          <p:spPr>
            <a:xfrm>
              <a:off x="910309" y="193959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4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11 CuadroTexto"/>
            <p:cNvSpPr txBox="1"/>
            <p:nvPr/>
          </p:nvSpPr>
          <p:spPr>
            <a:xfrm>
              <a:off x="910309" y="2199050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5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12 CuadroTexto"/>
            <p:cNvSpPr txBox="1"/>
            <p:nvPr/>
          </p:nvSpPr>
          <p:spPr>
            <a:xfrm>
              <a:off x="910309" y="2481749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6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>
              <a:off x="910309" y="2741206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7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957934" y="3278029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lnC</a:t>
              </a:r>
              <a:endParaRPr lang="es-E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938884" y="3542819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nM</a:t>
              </a:r>
              <a:endParaRPr lang="es-E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16 CuadroTexto"/>
            <p:cNvSpPr txBox="1"/>
            <p:nvPr/>
          </p:nvSpPr>
          <p:spPr>
            <a:xfrm>
              <a:off x="842442" y="3821326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10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851967" y="408078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11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842442" y="4343291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12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>
              <a:off x="842442" y="461227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13</a:t>
              </a:r>
              <a:endParaRPr lang="es-E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7 CuadroTexto"/>
          <p:cNvSpPr txBox="1"/>
          <p:nvPr/>
        </p:nvSpPr>
        <p:spPr>
          <a:xfrm>
            <a:off x="1331640" y="5539298"/>
            <a:ext cx="712879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2.-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lignment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f the 100 base pairs immediately upstream of the translation start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don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f all ORFs found in the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g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taining the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ntaricin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 locus. Putative ribosome binding sites (RBS) (pale blue) and start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don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yellow) are indicated.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7524609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63</Words>
  <Application>Microsoft Office PowerPoint</Application>
  <PresentationFormat>Presentación en pantalla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www.intercambiosvirtuales.org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altasar</dc:creator>
  <cp:lastModifiedBy>Inmaculada</cp:lastModifiedBy>
  <cp:revision>5</cp:revision>
  <dcterms:created xsi:type="dcterms:W3CDTF">2017-05-30T10:40:43Z</dcterms:created>
  <dcterms:modified xsi:type="dcterms:W3CDTF">2018-07-15T18:41:35Z</dcterms:modified>
</cp:coreProperties>
</file>